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67" d="100"/>
          <a:sy n="67" d="100"/>
        </p:scale>
        <p:origin x="572" y="5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9D44E-1DE2-49F0-99D4-B5D4174301AC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9E5FB-7208-4EEF-BFEA-F02E021D81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05627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9D44E-1DE2-49F0-99D4-B5D4174301AC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9E5FB-7208-4EEF-BFEA-F02E021D81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882251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9D44E-1DE2-49F0-99D4-B5D4174301AC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9E5FB-7208-4EEF-BFEA-F02E021D81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896479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9D44E-1DE2-49F0-99D4-B5D4174301AC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9E5FB-7208-4EEF-BFEA-F02E021D81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205129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9D44E-1DE2-49F0-99D4-B5D4174301AC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9E5FB-7208-4EEF-BFEA-F02E021D81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127574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9D44E-1DE2-49F0-99D4-B5D4174301AC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9E5FB-7208-4EEF-BFEA-F02E021D81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988766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9D44E-1DE2-49F0-99D4-B5D4174301AC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9E5FB-7208-4EEF-BFEA-F02E021D81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398150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9D44E-1DE2-49F0-99D4-B5D4174301AC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9E5FB-7208-4EEF-BFEA-F02E021D81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11676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9D44E-1DE2-49F0-99D4-B5D4174301AC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9E5FB-7208-4EEF-BFEA-F02E021D81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889882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9D44E-1DE2-49F0-99D4-B5D4174301AC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9E5FB-7208-4EEF-BFEA-F02E021D81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74918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9D44E-1DE2-49F0-99D4-B5D4174301AC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9E5FB-7208-4EEF-BFEA-F02E021D81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083202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D9D44E-1DE2-49F0-99D4-B5D4174301AC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09E5FB-7208-4EEF-BFEA-F02E021D81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98737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66595" y="322897"/>
            <a:ext cx="7796530" cy="4363403"/>
          </a:xfrm>
          <a:prstGeom prst="rect">
            <a:avLst/>
          </a:prstGeom>
          <a:noFill/>
        </p:spPr>
      </p:pic>
      <p:sp>
        <p:nvSpPr>
          <p:cNvPr id="5" name="Rectangle 4"/>
          <p:cNvSpPr/>
          <p:nvPr/>
        </p:nvSpPr>
        <p:spPr>
          <a:xfrm>
            <a:off x="2228850" y="4852511"/>
            <a:ext cx="73533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2.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cidence maps showing the spatial pattern of the DMN component identified with 30-ICA model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with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lor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dicating the percentage of animals displaying the pattern within each group: A) Females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KI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B) Females WT; C) Males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KI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D) Males WT. A minimum threshold of 25% was selected. The axial slices are shown at three levels (slice 1: rostral ACA;  slice 2: medial ACA;  slice 3: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trosplenial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rtex - RSP).</a:t>
            </a:r>
            <a:endParaRPr lang="fr-F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ZoneTexte 5"/>
          <p:cNvSpPr txBox="1"/>
          <p:nvPr/>
        </p:nvSpPr>
        <p:spPr>
          <a:xfrm>
            <a:off x="180975" y="138231"/>
            <a:ext cx="19718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l Fig 2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19314546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4</Words>
  <Application>Microsoft Office PowerPoint</Application>
  <PresentationFormat>Grand écran</PresentationFormat>
  <Paragraphs>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Harsan</dc:creator>
  <cp:lastModifiedBy>Harsan</cp:lastModifiedBy>
  <cp:revision>2</cp:revision>
  <dcterms:created xsi:type="dcterms:W3CDTF">2025-01-27T21:51:43Z</dcterms:created>
  <dcterms:modified xsi:type="dcterms:W3CDTF">2025-01-27T21:52:01Z</dcterms:modified>
</cp:coreProperties>
</file>